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84" y="10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8/10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10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10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10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10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10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10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10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10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10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10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10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8/10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95536" y="5347451"/>
            <a:ext cx="691276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eier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06306-1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Schematic overview of canonical IL-1β production and secretion</a:t>
            </a:r>
            <a:endParaRPr lang="en-GB" sz="1800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CC3101E-216E-3480-C619-5EA5561CBA6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83967" y="764703"/>
            <a:ext cx="5176066" cy="47112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51520" y="272842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Role of the NLRP3 inflammasome–IL-1β pathway in the pathogenesis of metabolic diseases and comorbidities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129E4ABB-1B96-8311-6BD4-A4201FAC948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59129" y="1083696"/>
            <a:ext cx="3425742" cy="450554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C4A615E-9DF1-2973-A8CF-3F407D24E556}"/>
              </a:ext>
            </a:extLst>
          </p:cNvPr>
          <p:cNvSpPr txBox="1"/>
          <p:nvPr/>
        </p:nvSpPr>
        <p:spPr>
          <a:xfrm>
            <a:off x="395536" y="5347451"/>
            <a:ext cx="691276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eier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06306-1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5</Words>
  <Application>Microsoft Office PowerPoint</Application>
  <PresentationFormat>On-screen Show (4:3)</PresentationFormat>
  <Paragraphs>11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47</cp:revision>
  <dcterms:created xsi:type="dcterms:W3CDTF">2016-06-15T12:53:43Z</dcterms:created>
  <dcterms:modified xsi:type="dcterms:W3CDTF">2024-10-28T15:26:18Z</dcterms:modified>
</cp:coreProperties>
</file>